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9" r:id="rId5"/>
    <p:sldId id="261" r:id="rId6"/>
    <p:sldId id="262" r:id="rId7"/>
    <p:sldId id="263" r:id="rId8"/>
    <p:sldId id="264" r:id="rId9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2006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745AB6-CF96-4CBA-860D-93F5B90C6A40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D99DB9-783D-487F-AD4F-741B3D4B95B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225B4F-BA59-4477-A2DA-448121B17CE3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6F771B-FE7D-4FEF-B59A-8DA4AD5ECA1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8AD6AD-32F8-4D97-9414-1F39C8517588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02E1F9-B5F6-4B40-9417-2340C355DF8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CB0106-03CF-4D30-8583-11ADF1155F5F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68A855-0364-4434-BBF7-7081C04CC10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7D51FE-B3BE-4DDD-9343-59C2FE87E8E0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95A681-475A-41BD-9208-7406ECA2ED5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DCBC79-AA8A-498E-A283-071CA36A8094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C1148B-79C9-4924-A0F4-D8FC5799BD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D021E3-7356-403B-986F-4D9FF52C2A2F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84885B-18E1-430C-86A2-53D60BA1ED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5206D9-FB09-47F4-A50D-5DEBDA421013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A5279E-2C14-46D0-8503-6EDA530D1E1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AC5BF9-137A-431C-BAA9-298C21335CD5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1D0975-64E6-4FDF-A055-5B67FDDA3F7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E93DD3-3EAB-4C76-BB35-474430E30F83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17FDE5-9B81-4C68-948E-A8CBABE5E2A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2072E0-1805-4058-AB26-16C34ADFF59E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14F091-D715-4A4E-A1B7-800B6D1F2C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02E756E2-7549-4375-9610-0A18F1072A09}" type="datetimeFigureOut">
              <a:rPr lang="en-US"/>
              <a:pPr>
                <a:defRPr/>
              </a:pPr>
              <a:t>3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3EDDCAD-058D-4A41-8E01-A7A4FAF450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09800" y="76200"/>
            <a:ext cx="6781800" cy="670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1" name="TextBox 4"/>
          <p:cNvSpPr txBox="1">
            <a:spLocks noChangeArrowheads="1"/>
          </p:cNvSpPr>
          <p:nvPr/>
        </p:nvSpPr>
        <p:spPr bwMode="auto">
          <a:xfrm>
            <a:off x="67860" y="513487"/>
            <a:ext cx="1913344" cy="17543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>
                <a:latin typeface="Calibri" pitchFamily="34" charset="0"/>
              </a:rPr>
              <a:t>DT-primer</a:t>
            </a:r>
          </a:p>
          <a:p>
            <a:r>
              <a:rPr lang="en-US" dirty="0">
                <a:latin typeface="Calibri" pitchFamily="34" charset="0"/>
              </a:rPr>
              <a:t>PCR-Pl-1</a:t>
            </a:r>
          </a:p>
          <a:p>
            <a:r>
              <a:rPr lang="en-US" dirty="0" smtClean="0">
                <a:latin typeface="Calibri" pitchFamily="34" charset="0"/>
              </a:rPr>
              <a:t>P1 = ICP5529 (IDT)</a:t>
            </a:r>
          </a:p>
          <a:p>
            <a:r>
              <a:rPr lang="en-US" dirty="0" smtClean="0">
                <a:latin typeface="Calibri" pitchFamily="34" charset="0"/>
              </a:rPr>
              <a:t>P2 =ICP11605 (DT)</a:t>
            </a:r>
          </a:p>
          <a:p>
            <a:r>
              <a:rPr lang="en-US" dirty="0" smtClean="0">
                <a:latin typeface="Calibri" pitchFamily="34" charset="0"/>
              </a:rPr>
              <a:t>F2:1 </a:t>
            </a:r>
            <a:r>
              <a:rPr lang="en-US" dirty="0">
                <a:latin typeface="Calibri" pitchFamily="34" charset="0"/>
              </a:rPr>
              <a:t>to </a:t>
            </a:r>
            <a:r>
              <a:rPr lang="en-US" dirty="0" smtClean="0">
                <a:latin typeface="Calibri" pitchFamily="34" charset="0"/>
              </a:rPr>
              <a:t>26</a:t>
            </a:r>
          </a:p>
          <a:p>
            <a:endParaRPr lang="en-US" dirty="0">
              <a:latin typeface="Calibri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286000" y="990600"/>
          <a:ext cx="6477004" cy="400050"/>
        </p:xfrm>
        <a:graphic>
          <a:graphicData uri="http://schemas.openxmlformats.org/drawingml/2006/table">
            <a:tbl>
              <a:tblPr/>
              <a:tblGrid>
                <a:gridCol w="457200"/>
                <a:gridCol w="381001"/>
                <a:gridCol w="457200"/>
                <a:gridCol w="381001"/>
                <a:gridCol w="381001"/>
                <a:gridCol w="381001"/>
                <a:gridCol w="457200"/>
                <a:gridCol w="381001"/>
                <a:gridCol w="338466"/>
                <a:gridCol w="451884"/>
                <a:gridCol w="376570"/>
                <a:gridCol w="451884"/>
                <a:gridCol w="376570"/>
                <a:gridCol w="376570"/>
                <a:gridCol w="376570"/>
                <a:gridCol w="451885"/>
              </a:tblGrid>
              <a:tr h="400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4831836"/>
              </p:ext>
            </p:extLst>
          </p:nvPr>
        </p:nvGraphicFramePr>
        <p:xfrm>
          <a:off x="2362200" y="4324350"/>
          <a:ext cx="6476996" cy="400050"/>
        </p:xfrm>
        <a:graphic>
          <a:graphicData uri="http://schemas.openxmlformats.org/drawingml/2006/table">
            <a:tbl>
              <a:tblPr/>
              <a:tblGrid>
                <a:gridCol w="380997"/>
                <a:gridCol w="381000"/>
                <a:gridCol w="381000"/>
                <a:gridCol w="408469"/>
                <a:gridCol w="421758"/>
                <a:gridCol w="421758"/>
                <a:gridCol w="421758"/>
                <a:gridCol w="421758"/>
                <a:gridCol w="421758"/>
                <a:gridCol w="421758"/>
                <a:gridCol w="421758"/>
                <a:gridCol w="421758"/>
                <a:gridCol w="421758"/>
                <a:gridCol w="421758"/>
                <a:gridCol w="403151"/>
                <a:gridCol w="304799"/>
              </a:tblGrid>
              <a:tr h="400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 rot="16200000">
            <a:off x="-1533435" y="3667036"/>
            <a:ext cx="4572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b="1" dirty="0"/>
              <a:t>ESM Figure 1. Genotyping of </a:t>
            </a:r>
            <a:r>
              <a:rPr lang="en-US" b="1" dirty="0" err="1"/>
              <a:t>Indel</a:t>
            </a:r>
            <a:r>
              <a:rPr lang="en-US" b="1" dirty="0"/>
              <a:t> marker (S3_20698771) derived from </a:t>
            </a:r>
            <a:r>
              <a:rPr lang="en-US" b="1" i="1" dirty="0"/>
              <a:t>CcTFL1</a:t>
            </a:r>
            <a:r>
              <a:rPr lang="en-US" b="1" dirty="0"/>
              <a:t> in F</a:t>
            </a:r>
            <a:r>
              <a:rPr lang="en-US" b="1" baseline="-25000" dirty="0"/>
              <a:t>2</a:t>
            </a:r>
            <a:r>
              <a:rPr lang="en-US" b="1" dirty="0"/>
              <a:t> population derived from ICP 5529 × ICP 11605</a:t>
            </a:r>
            <a:endParaRPr lang="en-IN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043113" y="152400"/>
            <a:ext cx="6815137" cy="657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5" name="TextBox 2"/>
          <p:cNvSpPr txBox="1">
            <a:spLocks noChangeArrowheads="1"/>
          </p:cNvSpPr>
          <p:nvPr/>
        </p:nvSpPr>
        <p:spPr bwMode="auto">
          <a:xfrm>
            <a:off x="152400" y="533400"/>
            <a:ext cx="1293813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>
                <a:latin typeface="Calibri" pitchFamily="34" charset="0"/>
              </a:rPr>
              <a:t>DT-primer</a:t>
            </a:r>
          </a:p>
          <a:p>
            <a:r>
              <a:rPr lang="en-US">
                <a:latin typeface="Calibri" pitchFamily="34" charset="0"/>
              </a:rPr>
              <a:t>PCR-Pl-1</a:t>
            </a:r>
          </a:p>
          <a:p>
            <a:r>
              <a:rPr lang="en-US">
                <a:latin typeface="Calibri" pitchFamily="34" charset="0"/>
              </a:rPr>
              <a:t>F2:27 to 54 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209800" y="990600"/>
          <a:ext cx="6324592" cy="533400"/>
        </p:xfrm>
        <a:graphic>
          <a:graphicData uri="http://schemas.openxmlformats.org/drawingml/2006/table">
            <a:tbl>
              <a:tblPr/>
              <a:tblGrid>
                <a:gridCol w="381000"/>
                <a:gridCol w="381000"/>
                <a:gridCol w="457200"/>
                <a:gridCol w="381000"/>
                <a:gridCol w="381000"/>
                <a:gridCol w="381000"/>
                <a:gridCol w="457200"/>
                <a:gridCol w="381000"/>
                <a:gridCol w="373730"/>
                <a:gridCol w="411834"/>
                <a:gridCol w="411834"/>
                <a:gridCol w="411834"/>
                <a:gridCol w="411834"/>
                <a:gridCol w="411834"/>
                <a:gridCol w="411834"/>
                <a:gridCol w="279458"/>
              </a:tblGrid>
              <a:tr h="533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2209800" y="4572000"/>
          <a:ext cx="6400794" cy="685800"/>
        </p:xfrm>
        <a:graphic>
          <a:graphicData uri="http://schemas.openxmlformats.org/drawingml/2006/table">
            <a:tbl>
              <a:tblPr/>
              <a:tblGrid>
                <a:gridCol w="380995"/>
                <a:gridCol w="381000"/>
                <a:gridCol w="381000"/>
                <a:gridCol w="457200"/>
                <a:gridCol w="381000"/>
                <a:gridCol w="385610"/>
                <a:gridCol w="452590"/>
                <a:gridCol w="381002"/>
                <a:gridCol w="457198"/>
                <a:gridCol w="381000"/>
                <a:gridCol w="412190"/>
                <a:gridCol w="416796"/>
                <a:gridCol w="416796"/>
                <a:gridCol w="416796"/>
                <a:gridCol w="416796"/>
                <a:gridCol w="282825"/>
              </a:tblGrid>
              <a:tr h="685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 l="2417" r="4532" b="7381"/>
          <a:stretch>
            <a:fillRect/>
          </a:stretch>
        </p:blipFill>
        <p:spPr bwMode="auto">
          <a:xfrm>
            <a:off x="2209800" y="76200"/>
            <a:ext cx="6858000" cy="670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99" name="TextBox 2"/>
          <p:cNvSpPr txBox="1">
            <a:spLocks noChangeArrowheads="1"/>
          </p:cNvSpPr>
          <p:nvPr/>
        </p:nvSpPr>
        <p:spPr bwMode="auto">
          <a:xfrm>
            <a:off x="152400" y="533400"/>
            <a:ext cx="1346200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>
                <a:latin typeface="Calibri" pitchFamily="34" charset="0"/>
              </a:rPr>
              <a:t>DT-primer</a:t>
            </a:r>
          </a:p>
          <a:p>
            <a:r>
              <a:rPr lang="en-US">
                <a:latin typeface="Calibri" pitchFamily="34" charset="0"/>
              </a:rPr>
              <a:t>PCR-Pl-1</a:t>
            </a:r>
          </a:p>
          <a:p>
            <a:r>
              <a:rPr lang="en-US">
                <a:latin typeface="Calibri" pitchFamily="34" charset="0"/>
              </a:rPr>
              <a:t>F2:55 to  82 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286000" y="762000"/>
          <a:ext cx="6629400" cy="609600"/>
        </p:xfrm>
        <a:graphic>
          <a:graphicData uri="http://schemas.openxmlformats.org/drawingml/2006/table">
            <a:tbl>
              <a:tblPr/>
              <a:tblGrid>
                <a:gridCol w="381001"/>
                <a:gridCol w="381000"/>
                <a:gridCol w="394289"/>
                <a:gridCol w="431682"/>
                <a:gridCol w="431682"/>
                <a:gridCol w="431682"/>
                <a:gridCol w="431682"/>
                <a:gridCol w="431682"/>
                <a:gridCol w="431682"/>
                <a:gridCol w="431682"/>
                <a:gridCol w="431682"/>
                <a:gridCol w="431682"/>
                <a:gridCol w="431682"/>
                <a:gridCol w="394291"/>
                <a:gridCol w="381000"/>
                <a:gridCol w="380999"/>
              </a:tblGrid>
              <a:tr h="609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2209800" y="4629150"/>
          <a:ext cx="6857992" cy="476250"/>
        </p:xfrm>
        <a:graphic>
          <a:graphicData uri="http://schemas.openxmlformats.org/drawingml/2006/table">
            <a:tbl>
              <a:tblPr/>
              <a:tblGrid>
                <a:gridCol w="381000"/>
                <a:gridCol w="457200"/>
                <a:gridCol w="457200"/>
                <a:gridCol w="381000"/>
                <a:gridCol w="412895"/>
                <a:gridCol w="446567"/>
                <a:gridCol w="446567"/>
                <a:gridCol w="446567"/>
                <a:gridCol w="446567"/>
                <a:gridCol w="446567"/>
                <a:gridCol w="446567"/>
                <a:gridCol w="446567"/>
                <a:gridCol w="446567"/>
                <a:gridCol w="446567"/>
                <a:gridCol w="292402"/>
                <a:gridCol w="457192"/>
              </a:tblGrid>
              <a:tr h="4762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028825" y="152400"/>
            <a:ext cx="7038975" cy="3797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23" name="TextBox 3"/>
          <p:cNvSpPr txBox="1">
            <a:spLocks noChangeArrowheads="1"/>
          </p:cNvSpPr>
          <p:nvPr/>
        </p:nvSpPr>
        <p:spPr bwMode="auto">
          <a:xfrm>
            <a:off x="152400" y="533400"/>
            <a:ext cx="1346200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>
                <a:latin typeface="Calibri" pitchFamily="34" charset="0"/>
              </a:rPr>
              <a:t>DT-primer</a:t>
            </a:r>
          </a:p>
          <a:p>
            <a:r>
              <a:rPr lang="en-US">
                <a:latin typeface="Calibri" pitchFamily="34" charset="0"/>
              </a:rPr>
              <a:t>PCR-Pl-1</a:t>
            </a:r>
          </a:p>
          <a:p>
            <a:r>
              <a:rPr lang="en-US">
                <a:latin typeface="Calibri" pitchFamily="34" charset="0"/>
              </a:rPr>
              <a:t>F2: 83 to 94 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209800" y="685800"/>
          <a:ext cx="6781794" cy="457200"/>
        </p:xfrm>
        <a:graphic>
          <a:graphicData uri="http://schemas.openxmlformats.org/drawingml/2006/table">
            <a:tbl>
              <a:tblPr/>
              <a:tblGrid>
                <a:gridCol w="457194"/>
                <a:gridCol w="457200"/>
                <a:gridCol w="457200"/>
                <a:gridCol w="533400"/>
                <a:gridCol w="533400"/>
                <a:gridCol w="457200"/>
                <a:gridCol w="457200"/>
                <a:gridCol w="457200"/>
                <a:gridCol w="533400"/>
                <a:gridCol w="455212"/>
                <a:gridCol w="535388"/>
                <a:gridCol w="456206"/>
                <a:gridCol w="495797"/>
                <a:gridCol w="495797"/>
              </a:tblGrid>
              <a:tr h="457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Box 1"/>
          <p:cNvSpPr txBox="1">
            <a:spLocks noChangeArrowheads="1"/>
          </p:cNvSpPr>
          <p:nvPr/>
        </p:nvSpPr>
        <p:spPr bwMode="auto">
          <a:xfrm>
            <a:off x="152400" y="381000"/>
            <a:ext cx="2103438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>
                <a:latin typeface="Calibri" pitchFamily="34" charset="0"/>
              </a:rPr>
              <a:t>DT-primer</a:t>
            </a:r>
          </a:p>
          <a:p>
            <a:r>
              <a:rPr lang="en-US">
                <a:latin typeface="Calibri" pitchFamily="34" charset="0"/>
              </a:rPr>
              <a:t>PCR-Pl-2</a:t>
            </a:r>
          </a:p>
          <a:p>
            <a:r>
              <a:rPr lang="en-US">
                <a:latin typeface="Calibri" pitchFamily="34" charset="0"/>
              </a:rPr>
              <a:t>P1, P2, F2: 95 to 120</a:t>
            </a:r>
          </a:p>
        </p:txBody>
      </p:sp>
      <p:pic>
        <p:nvPicPr>
          <p:cNvPr id="6147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09800" y="161925"/>
            <a:ext cx="6848475" cy="6467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362200" y="914400"/>
          <a:ext cx="6476996" cy="609600"/>
        </p:xfrm>
        <a:graphic>
          <a:graphicData uri="http://schemas.openxmlformats.org/drawingml/2006/table">
            <a:tbl>
              <a:tblPr/>
              <a:tblGrid>
                <a:gridCol w="457200"/>
                <a:gridCol w="381000"/>
                <a:gridCol w="381000"/>
                <a:gridCol w="457200"/>
                <a:gridCol w="381000"/>
                <a:gridCol w="381000"/>
                <a:gridCol w="381000"/>
                <a:gridCol w="457200"/>
                <a:gridCol w="381000"/>
                <a:gridCol w="424414"/>
                <a:gridCol w="421758"/>
                <a:gridCol w="373028"/>
                <a:gridCol w="457200"/>
                <a:gridCol w="381000"/>
                <a:gridCol w="381000"/>
                <a:gridCol w="380996"/>
              </a:tblGrid>
              <a:tr h="609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2362200" y="4800600"/>
          <a:ext cx="6553198" cy="533400"/>
        </p:xfrm>
        <a:graphic>
          <a:graphicData uri="http://schemas.openxmlformats.org/drawingml/2006/table">
            <a:tbl>
              <a:tblPr/>
              <a:tblGrid>
                <a:gridCol w="457198"/>
                <a:gridCol w="381000"/>
                <a:gridCol w="381000"/>
                <a:gridCol w="457200"/>
                <a:gridCol w="381000"/>
                <a:gridCol w="457200"/>
                <a:gridCol w="381000"/>
                <a:gridCol w="381000"/>
                <a:gridCol w="381000"/>
                <a:gridCol w="457200"/>
                <a:gridCol w="381000"/>
                <a:gridCol w="381000"/>
                <a:gridCol w="457200"/>
                <a:gridCol w="381000"/>
                <a:gridCol w="381000"/>
                <a:gridCol w="457200"/>
              </a:tblGrid>
              <a:tr h="533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extBox 2"/>
          <p:cNvSpPr txBox="1">
            <a:spLocks noChangeArrowheads="1"/>
          </p:cNvSpPr>
          <p:nvPr/>
        </p:nvSpPr>
        <p:spPr bwMode="auto">
          <a:xfrm>
            <a:off x="152400" y="381000"/>
            <a:ext cx="1527175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>
                <a:latin typeface="Calibri" pitchFamily="34" charset="0"/>
              </a:rPr>
              <a:t>DT-primer</a:t>
            </a:r>
          </a:p>
          <a:p>
            <a:r>
              <a:rPr lang="en-US">
                <a:latin typeface="Calibri" pitchFamily="34" charset="0"/>
              </a:rPr>
              <a:t>PCR-Pl-2</a:t>
            </a:r>
          </a:p>
          <a:p>
            <a:r>
              <a:rPr lang="en-US">
                <a:latin typeface="Calibri" pitchFamily="34" charset="0"/>
              </a:rPr>
              <a:t>F2: 121 to 148</a:t>
            </a:r>
          </a:p>
        </p:txBody>
      </p:sp>
      <p:pic>
        <p:nvPicPr>
          <p:cNvPr id="7171" name="Picture 3" descr="F:\jimmy\plate-2_SAMPLA 29 TO 56( 6 HOUR RUN)220920154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667000" y="76200"/>
            <a:ext cx="6324600" cy="663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667000" y="1295400"/>
          <a:ext cx="6172204" cy="533400"/>
        </p:xfrm>
        <a:graphic>
          <a:graphicData uri="http://schemas.openxmlformats.org/drawingml/2006/table">
            <a:tbl>
              <a:tblPr/>
              <a:tblGrid>
                <a:gridCol w="451625"/>
                <a:gridCol w="376354"/>
                <a:gridCol w="376354"/>
                <a:gridCol w="376354"/>
                <a:gridCol w="376354"/>
                <a:gridCol w="376354"/>
                <a:gridCol w="350796"/>
                <a:gridCol w="401911"/>
                <a:gridCol w="401911"/>
                <a:gridCol w="350796"/>
                <a:gridCol w="376354"/>
                <a:gridCol w="376354"/>
                <a:gridCol w="376354"/>
                <a:gridCol w="376354"/>
                <a:gridCol w="376354"/>
                <a:gridCol w="451625"/>
              </a:tblGrid>
              <a:tr h="533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2667000" y="4572000"/>
          <a:ext cx="6248404" cy="628650"/>
        </p:xfrm>
        <a:graphic>
          <a:graphicData uri="http://schemas.openxmlformats.org/drawingml/2006/table">
            <a:tbl>
              <a:tblPr/>
              <a:tblGrid>
                <a:gridCol w="457201"/>
                <a:gridCol w="381000"/>
                <a:gridCol w="381000"/>
                <a:gridCol w="381000"/>
                <a:gridCol w="381000"/>
                <a:gridCol w="457200"/>
                <a:gridCol w="381000"/>
                <a:gridCol w="381000"/>
                <a:gridCol w="381000"/>
                <a:gridCol w="356547"/>
                <a:gridCol w="406873"/>
                <a:gridCol w="379580"/>
                <a:gridCol w="381000"/>
                <a:gridCol w="381000"/>
                <a:gridCol w="381000"/>
                <a:gridCol w="381003"/>
              </a:tblGrid>
              <a:tr h="628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Box 1"/>
          <p:cNvSpPr txBox="1">
            <a:spLocks noChangeArrowheads="1"/>
          </p:cNvSpPr>
          <p:nvPr/>
        </p:nvSpPr>
        <p:spPr bwMode="auto">
          <a:xfrm>
            <a:off x="152400" y="381000"/>
            <a:ext cx="1527175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>
                <a:latin typeface="Calibri" pitchFamily="34" charset="0"/>
              </a:rPr>
              <a:t>DT-primer</a:t>
            </a:r>
          </a:p>
          <a:p>
            <a:r>
              <a:rPr lang="en-US">
                <a:latin typeface="Calibri" pitchFamily="34" charset="0"/>
              </a:rPr>
              <a:t>PCR-Pl-2</a:t>
            </a:r>
          </a:p>
          <a:p>
            <a:r>
              <a:rPr lang="en-US">
                <a:latin typeface="Calibri" pitchFamily="34" charset="0"/>
              </a:rPr>
              <a:t>F2: 149 to 176</a:t>
            </a:r>
          </a:p>
        </p:txBody>
      </p:sp>
      <p:grpSp>
        <p:nvGrpSpPr>
          <p:cNvPr id="8195" name="Group 4"/>
          <p:cNvGrpSpPr>
            <a:grpSpLocks/>
          </p:cNvGrpSpPr>
          <p:nvPr/>
        </p:nvGrpSpPr>
        <p:grpSpPr bwMode="auto">
          <a:xfrm>
            <a:off x="2438400" y="141288"/>
            <a:ext cx="6629400" cy="6665912"/>
            <a:chOff x="3124200" y="141549"/>
            <a:chExt cx="5943600" cy="6665522"/>
          </a:xfrm>
        </p:grpSpPr>
        <p:pic>
          <p:nvPicPr>
            <p:cNvPr id="8230" name="Picture 2" descr="F:\jimmy\plate-2_SAMPLA 71 TO 84( 4HOUR RUN)230920154.jpg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3124200" y="3429000"/>
              <a:ext cx="5943600" cy="33780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231" name="Picture 3" descr="G:\CAPS_deCAPS\jimmy\plate-2_SAMPLA 57 TO 70( 5HOUR RUN)240920154.jpg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124200" y="141549"/>
              <a:ext cx="5943600" cy="32874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2438400" y="1295400"/>
          <a:ext cx="6400802" cy="533400"/>
        </p:xfrm>
        <a:graphic>
          <a:graphicData uri="http://schemas.openxmlformats.org/drawingml/2006/table">
            <a:tbl>
              <a:tblPr/>
              <a:tblGrid>
                <a:gridCol w="425101"/>
                <a:gridCol w="413099"/>
                <a:gridCol w="381000"/>
                <a:gridCol w="457200"/>
                <a:gridCol w="381000"/>
                <a:gridCol w="371298"/>
                <a:gridCol w="420750"/>
                <a:gridCol w="350952"/>
                <a:gridCol w="457200"/>
                <a:gridCol w="381000"/>
                <a:gridCol w="381000"/>
                <a:gridCol w="457200"/>
                <a:gridCol w="381000"/>
                <a:gridCol w="381000"/>
                <a:gridCol w="381000"/>
                <a:gridCol w="381002"/>
              </a:tblGrid>
              <a:tr h="533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2514600" y="4876800"/>
          <a:ext cx="6400794" cy="533400"/>
        </p:xfrm>
        <a:graphic>
          <a:graphicData uri="http://schemas.openxmlformats.org/drawingml/2006/table">
            <a:tbl>
              <a:tblPr/>
              <a:tblGrid>
                <a:gridCol w="381005"/>
                <a:gridCol w="381000"/>
                <a:gridCol w="381000"/>
                <a:gridCol w="390208"/>
                <a:gridCol w="447992"/>
                <a:gridCol w="457200"/>
                <a:gridCol w="381000"/>
                <a:gridCol w="381000"/>
                <a:gridCol w="457200"/>
                <a:gridCol w="381000"/>
                <a:gridCol w="412180"/>
                <a:gridCol w="416796"/>
                <a:gridCol w="416796"/>
                <a:gridCol w="354428"/>
                <a:gridCol w="381000"/>
                <a:gridCol w="380989"/>
              </a:tblGrid>
              <a:tr h="533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/>
          <a:srcRect t="3522"/>
          <a:stretch>
            <a:fillRect/>
          </a:stretch>
        </p:blipFill>
        <p:spPr bwMode="auto">
          <a:xfrm>
            <a:off x="1947863" y="228600"/>
            <a:ext cx="7119937" cy="4175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219" name="TextBox 2"/>
          <p:cNvSpPr txBox="1">
            <a:spLocks noChangeArrowheads="1"/>
          </p:cNvSpPr>
          <p:nvPr/>
        </p:nvSpPr>
        <p:spPr bwMode="auto">
          <a:xfrm>
            <a:off x="152400" y="381000"/>
            <a:ext cx="1527175" cy="120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>
                <a:latin typeface="Calibri" pitchFamily="34" charset="0"/>
              </a:rPr>
              <a:t>DT-primer</a:t>
            </a:r>
          </a:p>
          <a:p>
            <a:r>
              <a:rPr lang="en-US">
                <a:latin typeface="Calibri" pitchFamily="34" charset="0"/>
              </a:rPr>
              <a:t>PCR-Pl-2</a:t>
            </a:r>
          </a:p>
          <a:p>
            <a:r>
              <a:rPr lang="en-US">
                <a:latin typeface="Calibri" pitchFamily="34" charset="0"/>
              </a:rPr>
              <a:t>F2: 177 to 188</a:t>
            </a:r>
          </a:p>
          <a:p>
            <a:endParaRPr lang="en-US">
              <a:latin typeface="Calibri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981200" y="2038350"/>
          <a:ext cx="6857997" cy="476250"/>
        </p:xfrm>
        <a:graphic>
          <a:graphicData uri="http://schemas.openxmlformats.org/drawingml/2006/table">
            <a:tbl>
              <a:tblPr/>
              <a:tblGrid>
                <a:gridCol w="457202"/>
                <a:gridCol w="533400"/>
                <a:gridCol w="457200"/>
                <a:gridCol w="533400"/>
                <a:gridCol w="457200"/>
                <a:gridCol w="457200"/>
                <a:gridCol w="533400"/>
                <a:gridCol w="457200"/>
                <a:gridCol w="533400"/>
                <a:gridCol w="457200"/>
                <a:gridCol w="533400"/>
                <a:gridCol w="533400"/>
                <a:gridCol w="413027"/>
                <a:gridCol w="501368"/>
              </a:tblGrid>
              <a:tr h="4762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1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FFFF00"/>
                          </a:solidFill>
                          <a:latin typeface="Calibri"/>
                        </a:rPr>
                        <a:t>1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FFFF00"/>
                          </a:solidFill>
                          <a:latin typeface="Calibri"/>
                        </a:rPr>
                        <a:t>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</TotalTime>
  <Words>310</Words>
  <Application>Microsoft Office PowerPoint</Application>
  <PresentationFormat>On-screen Show (4:3)</PresentationFormat>
  <Paragraphs>247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jimmy</dc:creator>
  <cp:lastModifiedBy>Saxena, Rachit (ICRISAT-IN)</cp:lastModifiedBy>
  <cp:revision>25</cp:revision>
  <dcterms:created xsi:type="dcterms:W3CDTF">2015-09-29T20:04:23Z</dcterms:created>
  <dcterms:modified xsi:type="dcterms:W3CDTF">2017-03-03T02:45:10Z</dcterms:modified>
</cp:coreProperties>
</file>